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2" r:id="rId2"/>
  </p:sldIdLst>
  <p:sldSz cx="9144000" cy="6858000" type="screen4x3"/>
  <p:notesSz cx="6858000" cy="9144000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0">
          <p15:clr>
            <a:srgbClr val="A4A3A4"/>
          </p15:clr>
        </p15:guide>
        <p15:guide id="2" pos="38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1716" y="108"/>
      </p:cViewPr>
      <p:guideLst>
        <p:guide orient="horz" pos="1480"/>
        <p:guide pos="38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0746A445-3AB4-4EC1-BFD1-711403A2897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B94FABC-18F3-474E-B5D0-157C12F5FCC6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91A76713-2E8D-41BD-BB48-CF377F8E2E99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4" name="슬라이드 이미지 개체 틀 3">
            <a:extLst>
              <a:ext uri="{FF2B5EF4-FFF2-40B4-BE49-F238E27FC236}">
                <a16:creationId xmlns:a16="http://schemas.microsoft.com/office/drawing/2014/main" id="{D15EC46E-CAA8-4C33-974E-BE8D7520962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>
            <a:extLst>
              <a:ext uri="{FF2B5EF4-FFF2-40B4-BE49-F238E27FC236}">
                <a16:creationId xmlns:a16="http://schemas.microsoft.com/office/drawing/2014/main" id="{E85CAF4B-0D4A-4D50-B9BC-5ED41BB80D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E8F9E2-AA7B-4786-8275-CDBAD4D2D750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6FDBB9-0AFC-446E-9A5E-A5BE46678FE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C2250BE7-74A3-45A2-8CB6-631A08C69C1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26B8DE-5FC1-4452-A9AF-4A9F69963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B9F72A27-DA70-44E5-9F4A-A190B63ECF56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F3B757-604D-4C9F-A349-01DE6F200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C3D695C-E130-4133-BB59-10F3411F0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69E9D6C0-58DC-4A74-8EE2-CC7E9121BD1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0092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AD26CC-DA46-486E-AC50-3497444DB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5981C31B-1194-45C2-B7CC-224F052B5B3D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8677A6A-5515-4F59-9E9A-518D51683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52AAE7-F1B6-4E99-9C00-B38441186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08AC9759-3B19-44F1-8AD9-760F783925A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652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CBDCEDC-A300-42FF-921E-F09B0B037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031F12B6-645F-445B-9FA9-ECF6A4B16D1D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C9B384-4C03-4260-8CB7-C5EB70CE5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6C589A1-8045-4505-826D-DADC771AF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D1E697F-6CFF-48E4-9DA4-634AEFA1683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5393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46842AD-27E2-41FE-AED1-5F7C4AD37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DB579E46-1C33-4152-863D-C2CB5024E308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BBA5113-9885-4CCC-96B6-ABB26B383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B5F295-E0AF-49CF-A6FC-9BADE4A36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87E1E1D0-F3BC-4B50-8D6B-92ADF200D7B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338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3887" y="1709744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3887" y="4589470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DADC40-7090-4F46-8014-C18C93331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9CF6B8CC-9386-4B65-9367-97DD40FC7337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18FD76-C101-46D9-9951-0FF36190F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6FE0FA-2E38-4575-8616-2EF347047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502484D0-1C1D-40D4-A7A5-16142BCCEFC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466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A891805-2339-47D3-9DC2-1C0001BD1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13B0755E-539F-45F0-A8B9-E21D83B8C39B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FC6E75-784F-40E4-8CED-B6D8F35FD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DDC90C-0B0F-47F9-809E-CBB8A5D00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0F47C7EF-4BE5-43EB-ADAE-45AA84E2894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307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8D6F91C-446F-4E8E-8BF2-2A438B8E7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13D588C5-DDA7-4E17-9A2E-2B271E77F872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2263389-A842-4611-B0FF-1F4CD71CD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BF3D13-79DC-481C-8031-01ECD4FAF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46F4F51-838B-44AD-A039-9152BF01C7E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047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643B0FD-26A3-4EE1-A9F5-5968D1508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BC7BA188-EDE7-4134-86D6-59AD592F526E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B29240A-AAFE-4CFE-9EAC-C5A55107A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97602E2-410A-4A9D-A05E-F64A51113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3E4AC617-FB84-4DC5-A24B-D2FE8273EDF7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2518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6DE257F-0DAE-43DF-880E-6DF088146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746DD04F-7F6F-4C8E-A350-5BC3E046E162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BB18D84-19D0-4768-A04C-83E1D6271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717654-C6BA-44F2-87C5-BA85A0888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EB96B731-4696-44F0-8CBE-1FBE284D377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8174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87391" y="987432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9A5C58A-F2F2-4ECF-A690-D1899B4E2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2D9419C1-615B-4F61-AA1F-E73023FE4098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3DC2A14-0EEB-470A-80B9-0FD0798B2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4834929-A2A7-4B60-BB7E-5B2931361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9E8EA27A-0CB9-441D-ACFE-C56CF3911F0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9195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987432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5EA5721-A2D2-4EFE-B5CC-F77574172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3F0859EB-6ED2-4CC4-8C1B-AB57AF70E1BA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054E5AB-BE09-4385-8C59-C2AD5D62F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F2CEF21-4188-41C3-9F18-F4D2D011F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F6B791B-1939-4A8E-B696-CCA8A5C80F1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9102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168096-7F4F-429C-9EDC-0934543AC1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fld id="{D08DCDD9-7E83-493D-8195-8360BBA00F27}" type="datetimeFigureOut">
              <a:rPr lang="ko-KR" altLang="en-US"/>
              <a:pPr>
                <a:defRPr/>
              </a:pPr>
              <a:t>2025-07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BA1428-D889-46FA-8BDA-7298A5D069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DA85304-84D2-41EF-95E1-CFE7FA0528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>
                <a:solidFill>
                  <a:srgbClr val="898989"/>
                </a:solidFill>
                <a:ea typeface="맑은 고딕" panose="020B0503020000020004" pitchFamily="50" charset="-127"/>
              </a:defRPr>
            </a:lvl1pPr>
          </a:lstStyle>
          <a:p>
            <a:pPr>
              <a:defRPr/>
            </a:pPr>
            <a:fld id="{A821B63D-CB7E-4A76-A95D-7AA18260192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93860" r:id="rId1"/>
    <p:sldLayoutId id="2147493861" r:id="rId2"/>
    <p:sldLayoutId id="2147493862" r:id="rId3"/>
    <p:sldLayoutId id="2147493863" r:id="rId4"/>
    <p:sldLayoutId id="2147493864" r:id="rId5"/>
    <p:sldLayoutId id="2147493865" r:id="rId6"/>
    <p:sldLayoutId id="2147493866" r:id="rId7"/>
    <p:sldLayoutId id="2147493867" r:id="rId8"/>
    <p:sldLayoutId id="2147493868" r:id="rId9"/>
    <p:sldLayoutId id="2147493869" r:id="rId10"/>
    <p:sldLayoutId id="2147493870" r:id="rId11"/>
  </p:sldLayoutIdLst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228600" indent="-228600" algn="l" rtl="0" eaLnBrk="0" fontAlgn="base" latinLnBrk="1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1682750" y="476672"/>
            <a:ext cx="4917770" cy="2042358"/>
            <a:chOff x="1682750" y="535831"/>
            <a:chExt cx="4917770" cy="2042358"/>
          </a:xfrm>
        </p:grpSpPr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B1E5F050-DD5C-426E-B9C7-1EF8E374F90F}"/>
                </a:ext>
              </a:extLst>
            </p:cNvPr>
            <p:cNvGrpSpPr/>
            <p:nvPr/>
          </p:nvGrpSpPr>
          <p:grpSpPr>
            <a:xfrm>
              <a:off x="6084168" y="1193056"/>
              <a:ext cx="396875" cy="249758"/>
              <a:chOff x="6580188" y="1193056"/>
              <a:chExt cx="396875" cy="249758"/>
            </a:xfrm>
          </p:grpSpPr>
          <p:cxnSp>
            <p:nvCxnSpPr>
              <p:cNvPr id="3" name="직선 연결선 2">
                <a:extLst>
                  <a:ext uri="{FF2B5EF4-FFF2-40B4-BE49-F238E27FC236}">
                    <a16:creationId xmlns:a16="http://schemas.microsoft.com/office/drawing/2014/main" id="{63C4E53B-52FA-469A-A296-07DD47B62792}"/>
                  </a:ext>
                </a:extLst>
              </p:cNvPr>
              <p:cNvCxnSpPr/>
              <p:nvPr/>
            </p:nvCxnSpPr>
            <p:spPr bwMode="auto">
              <a:xfrm>
                <a:off x="6602413" y="1193056"/>
                <a:ext cx="36036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92" name="TextBox 3"/>
              <p:cNvSpPr txBox="1">
                <a:spLocks noChangeArrowheads="1"/>
              </p:cNvSpPr>
              <p:nvPr/>
            </p:nvSpPr>
            <p:spPr bwMode="auto">
              <a:xfrm>
                <a:off x="6580188" y="1196752"/>
                <a:ext cx="396875" cy="246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1kb</a:t>
                </a:r>
                <a:endParaRPr lang="ko-KR" altLang="en-US" sz="10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B755EF49-54B1-4263-99B6-1B983D821F9F}"/>
                </a:ext>
              </a:extLst>
            </p:cNvPr>
            <p:cNvGrpSpPr/>
            <p:nvPr/>
          </p:nvGrpSpPr>
          <p:grpSpPr>
            <a:xfrm>
              <a:off x="1682750" y="535831"/>
              <a:ext cx="3969370" cy="628650"/>
              <a:chOff x="1682750" y="535831"/>
              <a:chExt cx="3969370" cy="628650"/>
            </a:xfrm>
          </p:grpSpPr>
          <p:grpSp>
            <p:nvGrpSpPr>
              <p:cNvPr id="9" name="그룹 8">
                <a:extLst>
                  <a:ext uri="{FF2B5EF4-FFF2-40B4-BE49-F238E27FC236}">
                    <a16:creationId xmlns:a16="http://schemas.microsoft.com/office/drawing/2014/main" id="{0EED1229-72E8-4079-A9EB-BC79E8F8434D}"/>
                  </a:ext>
                </a:extLst>
              </p:cNvPr>
              <p:cNvGrpSpPr/>
              <p:nvPr/>
            </p:nvGrpSpPr>
            <p:grpSpPr>
              <a:xfrm>
                <a:off x="2446254" y="535831"/>
                <a:ext cx="3205866" cy="628650"/>
                <a:chOff x="2446254" y="535831"/>
                <a:chExt cx="3205866" cy="628650"/>
              </a:xfrm>
            </p:grpSpPr>
            <p:sp>
              <p:nvSpPr>
                <p:cNvPr id="13" name="오른쪽 화살표 6">
                  <a:extLst>
                    <a:ext uri="{FF2B5EF4-FFF2-40B4-BE49-F238E27FC236}">
                      <a16:creationId xmlns:a16="http://schemas.microsoft.com/office/drawing/2014/main" id="{D0E37F1E-B30A-4AB1-BB18-2EF057EFB97A}"/>
                    </a:ext>
                  </a:extLst>
                </p:cNvPr>
                <p:cNvSpPr/>
                <p:nvPr/>
              </p:nvSpPr>
              <p:spPr bwMode="auto">
                <a:xfrm>
                  <a:off x="3774681" y="705693"/>
                  <a:ext cx="554400" cy="458788"/>
                </a:xfrm>
                <a:prstGeom prst="rightArrow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14" name="직선 연결선 13">
                  <a:extLst>
                    <a:ext uri="{FF2B5EF4-FFF2-40B4-BE49-F238E27FC236}">
                      <a16:creationId xmlns:a16="http://schemas.microsoft.com/office/drawing/2014/main" id="{62210534-8289-4FAB-A16C-3F53E2A78470}"/>
                    </a:ext>
                  </a:extLst>
                </p:cNvPr>
                <p:cNvCxnSpPr/>
                <p:nvPr/>
              </p:nvCxnSpPr>
              <p:spPr bwMode="auto">
                <a:xfrm>
                  <a:off x="3198812" y="929531"/>
                  <a:ext cx="5688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직선 연결선 14">
                  <a:extLst>
                    <a:ext uri="{FF2B5EF4-FFF2-40B4-BE49-F238E27FC236}">
                      <a16:creationId xmlns:a16="http://schemas.microsoft.com/office/drawing/2014/main" id="{B165DDD6-BB18-401F-A82E-8093F0A28352}"/>
                    </a:ext>
                  </a:extLst>
                </p:cNvPr>
                <p:cNvCxnSpPr/>
                <p:nvPr/>
              </p:nvCxnSpPr>
              <p:spPr bwMode="auto">
                <a:xfrm>
                  <a:off x="4320116" y="929531"/>
                  <a:ext cx="608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오른쪽 화살표 31">
                  <a:extLst>
                    <a:ext uri="{FF2B5EF4-FFF2-40B4-BE49-F238E27FC236}">
                      <a16:creationId xmlns:a16="http://schemas.microsoft.com/office/drawing/2014/main" id="{8348E5E6-E2B5-4E64-AB0B-3828F062BBB6}"/>
                    </a:ext>
                  </a:extLst>
                </p:cNvPr>
                <p:cNvSpPr/>
                <p:nvPr/>
              </p:nvSpPr>
              <p:spPr bwMode="auto">
                <a:xfrm>
                  <a:off x="3198813" y="623143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7" name="오른쪽 화살표 48">
                  <a:extLst>
                    <a:ext uri="{FF2B5EF4-FFF2-40B4-BE49-F238E27FC236}">
                      <a16:creationId xmlns:a16="http://schemas.microsoft.com/office/drawing/2014/main" id="{6E01A5A6-F3DC-45DC-913D-237F395C29EE}"/>
                    </a:ext>
                  </a:extLst>
                </p:cNvPr>
                <p:cNvSpPr/>
                <p:nvPr/>
              </p:nvSpPr>
              <p:spPr bwMode="auto">
                <a:xfrm flipH="1">
                  <a:off x="4826667" y="623143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88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3779912" y="796959"/>
                  <a:ext cx="50045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 dirty="0" err="1" smtClean="0">
                      <a:solidFill>
                        <a:schemeClr val="bg1"/>
                      </a:solidFill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afpA</a:t>
                  </a:r>
                  <a:endParaRPr lang="ko-KR" alt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89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2446254" y="535831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5</a:t>
                  </a:r>
                </a:p>
              </p:txBody>
            </p:sp>
            <p:sp>
              <p:nvSpPr>
                <p:cNvPr id="14390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4880755" y="535831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6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82" name="TextBox 70"/>
              <p:cNvSpPr txBox="1">
                <a:spLocks noChangeArrowheads="1"/>
              </p:cNvSpPr>
              <p:nvPr/>
            </p:nvSpPr>
            <p:spPr bwMode="auto">
              <a:xfrm>
                <a:off x="1682750" y="796959"/>
                <a:ext cx="432348" cy="2768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WT</a:t>
                </a:r>
                <a:endParaRPr lang="ko-KR" altLang="en-US" sz="12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54408644-FF8B-4C93-91D9-C5B27607DDF7}"/>
                </a:ext>
              </a:extLst>
            </p:cNvPr>
            <p:cNvGrpSpPr/>
            <p:nvPr/>
          </p:nvGrpSpPr>
          <p:grpSpPr>
            <a:xfrm>
              <a:off x="1685925" y="1196752"/>
              <a:ext cx="3948265" cy="681038"/>
              <a:chOff x="1685925" y="1264493"/>
              <a:chExt cx="3948265" cy="681038"/>
            </a:xfrm>
          </p:grpSpPr>
          <p:grpSp>
            <p:nvGrpSpPr>
              <p:cNvPr id="11" name="그룹 10">
                <a:extLst>
                  <a:ext uri="{FF2B5EF4-FFF2-40B4-BE49-F238E27FC236}">
                    <a16:creationId xmlns:a16="http://schemas.microsoft.com/office/drawing/2014/main" id="{58CF0029-1C09-464E-AFA4-CA582F28013F}"/>
                  </a:ext>
                </a:extLst>
              </p:cNvPr>
              <p:cNvGrpSpPr/>
              <p:nvPr/>
            </p:nvGrpSpPr>
            <p:grpSpPr>
              <a:xfrm>
                <a:off x="2447359" y="1264493"/>
                <a:ext cx="3186831" cy="681038"/>
                <a:chOff x="2447359" y="1264493"/>
                <a:chExt cx="3186831" cy="681038"/>
              </a:xfrm>
            </p:grpSpPr>
            <p:sp>
              <p:nvSpPr>
                <p:cNvPr id="34" name="오른쪽 화살표 6">
                  <a:extLst>
                    <a:ext uri="{FF2B5EF4-FFF2-40B4-BE49-F238E27FC236}">
                      <a16:creationId xmlns:a16="http://schemas.microsoft.com/office/drawing/2014/main" id="{AD5551A9-86BC-4426-8D52-8262939BC890}"/>
                    </a:ext>
                  </a:extLst>
                </p:cNvPr>
                <p:cNvSpPr/>
                <p:nvPr/>
              </p:nvSpPr>
              <p:spPr bwMode="auto">
                <a:xfrm>
                  <a:off x="3761712" y="1485156"/>
                  <a:ext cx="576263" cy="460375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35" name="직선 연결선 34">
                  <a:extLst>
                    <a:ext uri="{FF2B5EF4-FFF2-40B4-BE49-F238E27FC236}">
                      <a16:creationId xmlns:a16="http://schemas.microsoft.com/office/drawing/2014/main" id="{279FCCA8-6327-4BD3-99C9-7E8D0B665605}"/>
                    </a:ext>
                  </a:extLst>
                </p:cNvPr>
                <p:cNvCxnSpPr/>
                <p:nvPr/>
              </p:nvCxnSpPr>
              <p:spPr bwMode="auto">
                <a:xfrm>
                  <a:off x="3197224" y="1715343"/>
                  <a:ext cx="55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직선 연결선 35">
                  <a:extLst>
                    <a:ext uri="{FF2B5EF4-FFF2-40B4-BE49-F238E27FC236}">
                      <a16:creationId xmlns:a16="http://schemas.microsoft.com/office/drawing/2014/main" id="{02E60E78-6CF6-4732-8613-E96F3F35BCE6}"/>
                    </a:ext>
                  </a:extLst>
                </p:cNvPr>
                <p:cNvCxnSpPr/>
                <p:nvPr/>
              </p:nvCxnSpPr>
              <p:spPr bwMode="auto">
                <a:xfrm>
                  <a:off x="4341710" y="1715343"/>
                  <a:ext cx="572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오른쪽 화살표 31">
                  <a:extLst>
                    <a:ext uri="{FF2B5EF4-FFF2-40B4-BE49-F238E27FC236}">
                      <a16:creationId xmlns:a16="http://schemas.microsoft.com/office/drawing/2014/main" id="{F88D6A3B-C636-4FB8-A549-3B13101BC4FA}"/>
                    </a:ext>
                  </a:extLst>
                </p:cNvPr>
                <p:cNvSpPr/>
                <p:nvPr/>
              </p:nvSpPr>
              <p:spPr bwMode="auto">
                <a:xfrm>
                  <a:off x="3213100" y="1432768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38" name="오른쪽 화살표 48">
                  <a:extLst>
                    <a:ext uri="{FF2B5EF4-FFF2-40B4-BE49-F238E27FC236}">
                      <a16:creationId xmlns:a16="http://schemas.microsoft.com/office/drawing/2014/main" id="{89CF9790-49E0-4ABE-BB5E-EC5465EE6480}"/>
                    </a:ext>
                  </a:extLst>
                </p:cNvPr>
                <p:cNvSpPr/>
                <p:nvPr/>
              </p:nvSpPr>
              <p:spPr bwMode="auto">
                <a:xfrm flipH="1">
                  <a:off x="4808730" y="1424831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76" name="TextBox 38"/>
                <p:cNvSpPr txBox="1">
                  <a:spLocks noChangeArrowheads="1"/>
                </p:cNvSpPr>
                <p:nvPr/>
              </p:nvSpPr>
              <p:spPr bwMode="auto">
                <a:xfrm>
                  <a:off x="3750706" y="1577746"/>
                  <a:ext cx="514905" cy="2770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 dirty="0" err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pyrG</a:t>
                  </a:r>
                  <a:endParaRPr lang="ko-KR" altLang="en-US" sz="1200" i="1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77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4862825" y="1342871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6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이등변 삼각형 40">
                  <a:extLst>
                    <a:ext uri="{FF2B5EF4-FFF2-40B4-BE49-F238E27FC236}">
                      <a16:creationId xmlns:a16="http://schemas.microsoft.com/office/drawing/2014/main" id="{21ADFB62-C4A4-4F94-BA87-9EE0AB99BAB9}"/>
                    </a:ext>
                  </a:extLst>
                </p:cNvPr>
                <p:cNvSpPr/>
                <p:nvPr/>
              </p:nvSpPr>
              <p:spPr bwMode="auto">
                <a:xfrm flipH="1" flipV="1">
                  <a:off x="3967527" y="1489918"/>
                  <a:ext cx="71438" cy="10795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79" name="TextBox 41"/>
                <p:cNvSpPr txBox="1">
                  <a:spLocks noChangeArrowheads="1"/>
                </p:cNvSpPr>
                <p:nvPr/>
              </p:nvSpPr>
              <p:spPr bwMode="auto">
                <a:xfrm>
                  <a:off x="3625911" y="1264493"/>
                  <a:ext cx="481222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i="1" dirty="0" err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Kpn</a:t>
                  </a:r>
                  <a:r>
                    <a:rPr lang="en-US" altLang="ko-KR" sz="1000" i="1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 </a:t>
                  </a: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I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80" name="TextBox 68"/>
                <p:cNvSpPr txBox="1">
                  <a:spLocks noChangeArrowheads="1"/>
                </p:cNvSpPr>
                <p:nvPr/>
              </p:nvSpPr>
              <p:spPr bwMode="auto">
                <a:xfrm>
                  <a:off x="2447359" y="1342871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5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69" name="TextBox 71"/>
              <p:cNvSpPr txBox="1">
                <a:spLocks noChangeArrowheads="1"/>
              </p:cNvSpPr>
              <p:nvPr/>
            </p:nvSpPr>
            <p:spPr bwMode="auto">
              <a:xfrm>
                <a:off x="1685925" y="1577153"/>
                <a:ext cx="62068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 err="1" smtClean="0">
                    <a:latin typeface="Symbol" panose="05050102010706020507" pitchFamily="18" charset="2"/>
                    <a:ea typeface="굴림" panose="020B0600000101010101" pitchFamily="50" charset="-127"/>
                    <a:cs typeface="Arial" panose="020B0604020202020204" pitchFamily="34" charset="0"/>
                  </a:rPr>
                  <a:t>D</a:t>
                </a:r>
                <a:r>
                  <a:rPr lang="en-US" altLang="ko-KR" sz="1200" b="1" i="1" dirty="0" err="1" smtClean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afpA</a:t>
                </a:r>
                <a:endParaRPr lang="ko-KR" altLang="en-US" sz="1200" b="1" i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id="{CBB188C2-F869-455D-9AEF-86B5F92ABC57}"/>
                </a:ext>
              </a:extLst>
            </p:cNvPr>
            <p:cNvGrpSpPr/>
            <p:nvPr/>
          </p:nvGrpSpPr>
          <p:grpSpPr>
            <a:xfrm>
              <a:off x="1682750" y="1916832"/>
              <a:ext cx="4917770" cy="661357"/>
              <a:chOff x="1682750" y="2087449"/>
              <a:chExt cx="4917770" cy="661357"/>
            </a:xfrm>
          </p:grpSpPr>
          <p:grpSp>
            <p:nvGrpSpPr>
              <p:cNvPr id="12" name="그룹 11">
                <a:extLst>
                  <a:ext uri="{FF2B5EF4-FFF2-40B4-BE49-F238E27FC236}">
                    <a16:creationId xmlns:a16="http://schemas.microsoft.com/office/drawing/2014/main" id="{2BF8FC80-96F8-4814-8B8E-2E179982A626}"/>
                  </a:ext>
                </a:extLst>
              </p:cNvPr>
              <p:cNvGrpSpPr/>
              <p:nvPr/>
            </p:nvGrpSpPr>
            <p:grpSpPr>
              <a:xfrm>
                <a:off x="2439785" y="2087449"/>
                <a:ext cx="4160735" cy="661357"/>
                <a:chOff x="2439785" y="2087449"/>
                <a:chExt cx="4160735" cy="661357"/>
              </a:xfrm>
            </p:grpSpPr>
            <p:sp>
              <p:nvSpPr>
                <p:cNvPr id="43" name="오른쪽 화살표 6">
                  <a:extLst>
                    <a:ext uri="{FF2B5EF4-FFF2-40B4-BE49-F238E27FC236}">
                      <a16:creationId xmlns:a16="http://schemas.microsoft.com/office/drawing/2014/main" id="{4DECA1A8-5E9B-42D3-B3E2-18E64419345E}"/>
                    </a:ext>
                  </a:extLst>
                </p:cNvPr>
                <p:cNvSpPr/>
                <p:nvPr/>
              </p:nvSpPr>
              <p:spPr bwMode="auto">
                <a:xfrm>
                  <a:off x="3765716" y="2290018"/>
                  <a:ext cx="554400" cy="458788"/>
                </a:xfrm>
                <a:prstGeom prst="rightArrow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44" name="직선 연결선 43">
                  <a:extLst>
                    <a:ext uri="{FF2B5EF4-FFF2-40B4-BE49-F238E27FC236}">
                      <a16:creationId xmlns:a16="http://schemas.microsoft.com/office/drawing/2014/main" id="{D38C94AC-C426-4041-B65A-6F50A1462812}"/>
                    </a:ext>
                  </a:extLst>
                </p:cNvPr>
                <p:cNvCxnSpPr/>
                <p:nvPr/>
              </p:nvCxnSpPr>
              <p:spPr bwMode="auto">
                <a:xfrm>
                  <a:off x="3192463" y="2507506"/>
                  <a:ext cx="5688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>
                  <a:extLst>
                    <a:ext uri="{FF2B5EF4-FFF2-40B4-BE49-F238E27FC236}">
                      <a16:creationId xmlns:a16="http://schemas.microsoft.com/office/drawing/2014/main" id="{CC285827-CD75-459C-B287-9ABC6248A553}"/>
                    </a:ext>
                  </a:extLst>
                </p:cNvPr>
                <p:cNvCxnSpPr/>
                <p:nvPr/>
              </p:nvCxnSpPr>
              <p:spPr bwMode="auto">
                <a:xfrm>
                  <a:off x="5346158" y="2512268"/>
                  <a:ext cx="5616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오른쪽 화살표 31">
                  <a:extLst>
                    <a:ext uri="{FF2B5EF4-FFF2-40B4-BE49-F238E27FC236}">
                      <a16:creationId xmlns:a16="http://schemas.microsoft.com/office/drawing/2014/main" id="{2B76BC52-3D9D-4055-A766-C86B810CB813}"/>
                    </a:ext>
                  </a:extLst>
                </p:cNvPr>
                <p:cNvSpPr/>
                <p:nvPr/>
              </p:nvSpPr>
              <p:spPr bwMode="auto">
                <a:xfrm>
                  <a:off x="3192463" y="2177306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47" name="오른쪽 화살표 48">
                  <a:extLst>
                    <a:ext uri="{FF2B5EF4-FFF2-40B4-BE49-F238E27FC236}">
                      <a16:creationId xmlns:a16="http://schemas.microsoft.com/office/drawing/2014/main" id="{7422FBF2-A52C-4984-B0A0-94C6ADA07576}"/>
                    </a:ext>
                  </a:extLst>
                </p:cNvPr>
                <p:cNvSpPr/>
                <p:nvPr/>
              </p:nvSpPr>
              <p:spPr bwMode="auto">
                <a:xfrm flipH="1">
                  <a:off x="5778206" y="2177306"/>
                  <a:ext cx="107950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58" name="TextBox 47"/>
                <p:cNvSpPr txBox="1">
                  <a:spLocks noChangeArrowheads="1"/>
                </p:cNvSpPr>
                <p:nvPr/>
              </p:nvSpPr>
              <p:spPr bwMode="auto">
                <a:xfrm>
                  <a:off x="3729136" y="2381630"/>
                  <a:ext cx="50045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 dirty="0" err="1" smtClean="0">
                      <a:solidFill>
                        <a:schemeClr val="bg1"/>
                      </a:solidFill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afpA</a:t>
                  </a:r>
                  <a:endParaRPr lang="ko-KR" alt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59" name="TextBox 48"/>
                <p:cNvSpPr txBox="1">
                  <a:spLocks noChangeArrowheads="1"/>
                </p:cNvSpPr>
                <p:nvPr/>
              </p:nvSpPr>
              <p:spPr bwMode="auto">
                <a:xfrm>
                  <a:off x="5829155" y="2098496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6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오른쪽 화살표 6">
                  <a:extLst>
                    <a:ext uri="{FF2B5EF4-FFF2-40B4-BE49-F238E27FC236}">
                      <a16:creationId xmlns:a16="http://schemas.microsoft.com/office/drawing/2014/main" id="{38671206-ABFB-4B86-8578-B4B84761E742}"/>
                    </a:ext>
                  </a:extLst>
                </p:cNvPr>
                <p:cNvSpPr/>
                <p:nvPr/>
              </p:nvSpPr>
              <p:spPr bwMode="auto">
                <a:xfrm>
                  <a:off x="4347299" y="2285256"/>
                  <a:ext cx="1004887" cy="458787"/>
                </a:xfrm>
                <a:prstGeom prst="rightArrow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63" name="TextBox 52"/>
                <p:cNvSpPr txBox="1">
                  <a:spLocks noChangeArrowheads="1"/>
                </p:cNvSpPr>
                <p:nvPr/>
              </p:nvSpPr>
              <p:spPr bwMode="auto">
                <a:xfrm>
                  <a:off x="4515776" y="2368805"/>
                  <a:ext cx="542145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 dirty="0" err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hygR</a:t>
                  </a:r>
                  <a:endParaRPr lang="ko-KR" altLang="en-US" sz="1200" i="1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4" name="직선 연결선 63">
                  <a:extLst>
                    <a:ext uri="{FF2B5EF4-FFF2-40B4-BE49-F238E27FC236}">
                      <a16:creationId xmlns:a16="http://schemas.microsoft.com/office/drawing/2014/main" id="{B14C7DDF-F32C-4BB3-A771-FDE7772610E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311151" y="2513856"/>
                  <a:ext cx="36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67" name="TextBox 69"/>
                <p:cNvSpPr txBox="1">
                  <a:spLocks noChangeArrowheads="1"/>
                </p:cNvSpPr>
                <p:nvPr/>
              </p:nvSpPr>
              <p:spPr bwMode="auto">
                <a:xfrm>
                  <a:off x="2439785" y="2087449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535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52" name="TextBox 72"/>
              <p:cNvSpPr txBox="1">
                <a:spLocks noChangeArrowheads="1"/>
              </p:cNvSpPr>
              <p:nvPr/>
            </p:nvSpPr>
            <p:spPr bwMode="auto">
              <a:xfrm>
                <a:off x="1682750" y="2398279"/>
                <a:ext cx="332142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 smtClean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C'</a:t>
                </a:r>
                <a:endParaRPr lang="ko-KR" altLang="en-US" sz="12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4342" name="TextBox 1"/>
          <p:cNvSpPr txBox="1">
            <a:spLocks noChangeArrowheads="1"/>
          </p:cNvSpPr>
          <p:nvPr/>
        </p:nvSpPr>
        <p:spPr bwMode="auto">
          <a:xfrm>
            <a:off x="1395413" y="116632"/>
            <a:ext cx="18669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. Restriction maps</a:t>
            </a:r>
            <a:endParaRPr lang="ko-KR" altLang="en-US" sz="1400" b="1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4348" name="TextBox 50"/>
          <p:cNvSpPr txBox="1">
            <a:spLocks noChangeArrowheads="1"/>
          </p:cNvSpPr>
          <p:nvPr/>
        </p:nvSpPr>
        <p:spPr bwMode="auto">
          <a:xfrm>
            <a:off x="1395413" y="2780928"/>
            <a:ext cx="1728547" cy="3078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. PCR amplicons</a:t>
            </a:r>
            <a:endParaRPr lang="ko-KR" altLang="en-US" sz="1400" b="1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4345" name="TextBox 52"/>
          <p:cNvSpPr txBox="1">
            <a:spLocks noChangeArrowheads="1"/>
          </p:cNvSpPr>
          <p:nvPr/>
        </p:nvSpPr>
        <p:spPr bwMode="auto">
          <a:xfrm>
            <a:off x="5148263" y="2780928"/>
            <a:ext cx="29498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C. PCR amplicons cut with </a:t>
            </a:r>
            <a:r>
              <a:rPr lang="en-US" altLang="ko-KR" sz="1400" b="1" i="1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pn</a:t>
            </a: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 I</a:t>
            </a:r>
            <a:endParaRPr lang="ko-KR" altLang="en-US" sz="1400" b="1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678381" y="6237312"/>
            <a:ext cx="82812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ko-KR" sz="11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</a:t>
            </a:r>
            <a:r>
              <a:rPr lang="en-US" altLang="ko-KR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onfirmation of WT, mutants, and complemented strains. (A) Schematic illustration for </a:t>
            </a:r>
            <a:r>
              <a:rPr lang="en-US" altLang="ko-KR" sz="1100" i="1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fpA</a:t>
            </a:r>
            <a:r>
              <a:rPr lang="en-US" altLang="ko-KR" sz="1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ene region of WT, mutants, and complemented strains, respectively. (B) PCR </a:t>
            </a:r>
            <a:r>
              <a:rPr lang="en-US" altLang="ko-KR" sz="110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esults </a:t>
            </a:r>
            <a:r>
              <a:rPr lang="en-US" altLang="ko-KR" sz="110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f </a:t>
            </a:r>
            <a:r>
              <a:rPr lang="en-US" altLang="ko-KR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T, mutants, and </a:t>
            </a:r>
            <a:r>
              <a:rPr lang="en-US" altLang="ko-KR" sz="110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mplemented </a:t>
            </a:r>
            <a:r>
              <a:rPr lang="en-US" altLang="ko-KR" sz="110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rains. (</a:t>
            </a:r>
            <a:r>
              <a:rPr lang="en-US" altLang="ko-KR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</a:t>
            </a:r>
            <a:r>
              <a:rPr lang="en-US" altLang="ko-KR" sz="1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</a:t>
            </a:r>
            <a:r>
              <a:rPr lang="en-US" altLang="ko-KR" sz="11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Kpn</a:t>
            </a:r>
            <a:r>
              <a:rPr lang="en-US" altLang="ko-KR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 digestion pattern of the individual amplicons. </a:t>
            </a:r>
            <a:endParaRPr lang="ko-KR" altLang="ko-KR" sz="11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1682750" y="3068960"/>
            <a:ext cx="1973223" cy="3119551"/>
            <a:chOff x="1682750" y="3221911"/>
            <a:chExt cx="1973223" cy="3119551"/>
          </a:xfrm>
        </p:grpSpPr>
        <p:sp>
          <p:nvSpPr>
            <p:cNvPr id="14350" name="TextBox 18"/>
            <p:cNvSpPr txBox="1">
              <a:spLocks noChangeArrowheads="1"/>
            </p:cNvSpPr>
            <p:nvPr/>
          </p:nvSpPr>
          <p:spPr bwMode="auto">
            <a:xfrm>
              <a:off x="1817977" y="3221911"/>
              <a:ext cx="181972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100" dirty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M       WT </a:t>
              </a:r>
              <a:r>
                <a:rPr lang="en-US" altLang="ko-KR" sz="1100" dirty="0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 </a:t>
              </a:r>
              <a:r>
                <a:rPr lang="en-US" altLang="ko-KR" sz="1100" dirty="0" err="1" smtClean="0">
                  <a:latin typeface="Symbol" panose="05050102010706020507" pitchFamily="18" charset="2"/>
                  <a:ea typeface="굴림" panose="020B0600000101010101" pitchFamily="50" charset="-127"/>
                  <a:cs typeface="Arial" panose="020B0604020202020204" pitchFamily="34" charset="0"/>
                </a:rPr>
                <a:t>D</a:t>
              </a:r>
              <a:r>
                <a:rPr lang="en-US" altLang="ko-KR" sz="1100" i="1" dirty="0" err="1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afpA</a:t>
              </a:r>
              <a:r>
                <a:rPr lang="en-US" altLang="ko-KR" sz="1100" dirty="0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   C'         </a:t>
              </a:r>
              <a:r>
                <a:rPr lang="en-US" altLang="ko-KR" sz="1100" dirty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M </a:t>
              </a:r>
              <a:endParaRPr lang="ko-KR" altLang="en-US" sz="1100" dirty="0">
                <a:latin typeface="Arial Narrow" panose="020B060602020203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8EA5B486-C082-4A20-BD74-357AD4C9C2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15" t="43962" r="53185" b="38632"/>
            <a:stretch/>
          </p:blipFill>
          <p:spPr>
            <a:xfrm>
              <a:off x="1682750" y="3446930"/>
              <a:ext cx="1973223" cy="2894532"/>
            </a:xfrm>
            <a:prstGeom prst="rect">
              <a:avLst/>
            </a:prstGeom>
          </p:spPr>
        </p:pic>
      </p:grpSp>
      <p:grpSp>
        <p:nvGrpSpPr>
          <p:cNvPr id="6" name="그룹 5"/>
          <p:cNvGrpSpPr/>
          <p:nvPr/>
        </p:nvGrpSpPr>
        <p:grpSpPr>
          <a:xfrm>
            <a:off x="5453256" y="3068960"/>
            <a:ext cx="2005071" cy="3122557"/>
            <a:chOff x="5453256" y="3218905"/>
            <a:chExt cx="2005071" cy="3122557"/>
          </a:xfrm>
        </p:grpSpPr>
        <p:sp>
          <p:nvSpPr>
            <p:cNvPr id="14347" name="TextBox 18"/>
            <p:cNvSpPr txBox="1">
              <a:spLocks noChangeArrowheads="1"/>
            </p:cNvSpPr>
            <p:nvPr/>
          </p:nvSpPr>
          <p:spPr bwMode="auto">
            <a:xfrm>
              <a:off x="5549539" y="3218905"/>
              <a:ext cx="188384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100" dirty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M       WT  </a:t>
              </a:r>
              <a:r>
                <a:rPr lang="en-US" altLang="ko-KR" sz="1100" dirty="0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</a:t>
              </a:r>
              <a:r>
                <a:rPr lang="en-US" altLang="ko-KR" sz="1100" dirty="0" err="1" smtClean="0">
                  <a:latin typeface="Symbol" panose="05050102010706020507" pitchFamily="18" charset="2"/>
                  <a:ea typeface="굴림" panose="020B0600000101010101" pitchFamily="50" charset="-127"/>
                  <a:cs typeface="Arial" panose="020B0604020202020204" pitchFamily="34" charset="0"/>
                </a:rPr>
                <a:t>D</a:t>
              </a:r>
              <a:r>
                <a:rPr lang="en-US" altLang="ko-KR" sz="1100" i="1" dirty="0" err="1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afpA</a:t>
              </a:r>
              <a:r>
                <a:rPr lang="en-US" altLang="ko-KR" sz="1100" dirty="0" smtClean="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    C'        M   </a:t>
              </a:r>
              <a:endParaRPr lang="ko-KR" altLang="en-US" sz="1100" dirty="0">
                <a:latin typeface="Arial Narrow" panose="020B060602020203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61" name="그림 60">
              <a:extLst>
                <a:ext uri="{FF2B5EF4-FFF2-40B4-BE49-F238E27FC236}">
                  <a16:creationId xmlns:a16="http://schemas.microsoft.com/office/drawing/2014/main" id="{4AD8DB96-DB7A-4C86-BDD0-D80576FD5B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917" t="43962" r="46039" b="38632"/>
            <a:stretch/>
          </p:blipFill>
          <p:spPr>
            <a:xfrm>
              <a:off x="5453256" y="3446930"/>
              <a:ext cx="2005071" cy="28945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4723784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59</TotalTime>
  <Words>110</Words>
  <Application>Microsoft Office PowerPoint</Application>
  <PresentationFormat>화면 슬라이드 쇼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굴림</vt:lpstr>
      <vt:lpstr>맑은 고딕</vt:lpstr>
      <vt:lpstr>Arial</vt:lpstr>
      <vt:lpstr>Arial Narrow</vt:lpstr>
      <vt:lpstr>Symbol</vt:lpstr>
      <vt:lpstr>Times New Roman</vt:lpstr>
      <vt:lpstr>1_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광수</dc:creator>
  <cp:lastModifiedBy>K.S.Shin</cp:lastModifiedBy>
  <cp:revision>202</cp:revision>
  <dcterms:created xsi:type="dcterms:W3CDTF">2014-03-26T07:12:01Z</dcterms:created>
  <dcterms:modified xsi:type="dcterms:W3CDTF">2025-07-01T03:21:20Z</dcterms:modified>
</cp:coreProperties>
</file>